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E8E1AD-D628-45E5-9ECE-60352AAFBF1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412970-A22D-45D9-A8FA-A0367A2BA2E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033B48-EBCE-4B44-9F6E-7D6863D60BC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DE219A-02FD-45B8-915F-849C14F32AB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109CFA-B116-463B-B242-526CEBCB6E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A89E0B-00DC-41BD-92D2-B463F46141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E373F4-966B-41E8-A700-E9CBDC067D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FEF555-66C2-4898-96D1-23225FDFBD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20D621-C79B-4A12-A223-2701F0985D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E9F729-2FBC-4050-AC3F-AC3A0B092B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957D0A-DC7C-4836-90DC-B9CB958E0B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2FA0B7-2C26-4235-A2EA-1C15BE8E4E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E9A932E-4EC6-4AD4-84ED-1A93DC8D9578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表 1" descr=""/>
          <p:cNvPicPr/>
          <p:nvPr/>
        </p:nvPicPr>
        <p:blipFill>
          <a:blip r:embed="rId1"/>
          <a:stretch/>
        </p:blipFill>
        <p:spPr>
          <a:xfrm>
            <a:off x="1444680" y="1768320"/>
            <a:ext cx="3700440" cy="2316240"/>
          </a:xfrm>
          <a:prstGeom prst="rect">
            <a:avLst/>
          </a:prstGeom>
          <a:ln w="0">
            <a:noFill/>
          </a:ln>
        </p:spPr>
      </p:pic>
      <p:sp>
        <p:nvSpPr>
          <p:cNvPr id="42" name="TextBox 2"/>
          <p:cNvSpPr/>
          <p:nvPr/>
        </p:nvSpPr>
        <p:spPr>
          <a:xfrm>
            <a:off x="458640" y="1231920"/>
            <a:ext cx="990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Fig. S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矩形 3"/>
          <p:cNvSpPr/>
          <p:nvPr/>
        </p:nvSpPr>
        <p:spPr>
          <a:xfrm>
            <a:off x="157320" y="4103640"/>
            <a:ext cx="642132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3.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IP assay using antibody against Sp1 was performed in HT-29 cells and Sp1-shRNA cells. The normal rabbit IgG was used as a negative control ,the anti-polymerase-Ⅱ antibody was used as positive control. Input indicates 5% input DNA, a positive amplification control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19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0-24T08:23:54Z</dcterms:created>
  <dc:creator>lj</dc:creator>
  <dc:description/>
  <dc:language>en-US</dc:language>
  <cp:lastModifiedBy>vidya.p</cp:lastModifiedBy>
  <cp:lastPrinted>2016-03-10T05:57:39Z</cp:lastPrinted>
  <dcterms:modified xsi:type="dcterms:W3CDTF">2017-09-28T04:24:27Z</dcterms:modified>
  <cp:revision>423</cp:revision>
  <dc:subject/>
  <dc:title>幻灯片 1</dc:title>
</cp:coreProperties>
</file>